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18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BF0CC-3817-46F6-BB6D-0BFF12039974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E21438-E647-49CD-AFBC-D24D5B91B99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xmlns="" id="{5CF978F4-2214-184C-AA5C-E32D67ED495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284" y="395976"/>
            <a:ext cx="6840000" cy="432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8640" y="6660232"/>
            <a:ext cx="62646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1. SARS-CoV-2 MHC bound peptide identification and specific T generation workflow </a:t>
            </a:r>
            <a:endParaRPr lang="zh-CN" altLang="en-US" sz="16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8640" y="6660232"/>
            <a:ext cx="63367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2. The five candidate SARS-CoV-2 peptide sequences were located in conserved region of SARS-CoV-2 genome.</a:t>
            </a:r>
            <a:endParaRPr lang="zh-CN" altLang="en-US" sz="1600" b="1" dirty="0"/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4AA11925-31F3-A14A-A847-42298A09E21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3061"/>
          <a:stretch>
            <a:fillRect/>
          </a:stretch>
        </p:blipFill>
        <p:spPr>
          <a:xfrm>
            <a:off x="188640" y="683568"/>
            <a:ext cx="6442918" cy="374441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0688" y="35976"/>
            <a:ext cx="6128767" cy="4320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412776" y="17951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3429000" y="17951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2420888" y="17951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4437112" y="17951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1412776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3429000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2420888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1412776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3429000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2420888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4437112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1412776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3429000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2420888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4437112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5" name="Picture 2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0688" y="4355976"/>
            <a:ext cx="6128767" cy="4320000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1412776" y="449999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5445224" y="449999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2420888" y="449999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4437112" y="449999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/>
          <p:cNvSpPr/>
          <p:nvPr/>
        </p:nvSpPr>
        <p:spPr>
          <a:xfrm>
            <a:off x="6381328" y="4499992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1412776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/>
          <p:cNvSpPr/>
          <p:nvPr/>
        </p:nvSpPr>
        <p:spPr>
          <a:xfrm>
            <a:off x="5445224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/>
          <p:cNvSpPr/>
          <p:nvPr/>
        </p:nvSpPr>
        <p:spPr>
          <a:xfrm>
            <a:off x="2420888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/>
          <p:cNvSpPr/>
          <p:nvPr/>
        </p:nvSpPr>
        <p:spPr>
          <a:xfrm>
            <a:off x="3429000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6381328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/>
          <p:cNvSpPr/>
          <p:nvPr/>
        </p:nvSpPr>
        <p:spPr>
          <a:xfrm>
            <a:off x="1412776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4437112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2420888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矩形 48"/>
          <p:cNvSpPr/>
          <p:nvPr/>
        </p:nvSpPr>
        <p:spPr>
          <a:xfrm>
            <a:off x="3429000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/>
          <p:cNvSpPr/>
          <p:nvPr/>
        </p:nvSpPr>
        <p:spPr>
          <a:xfrm>
            <a:off x="5373216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矩形 50"/>
          <p:cNvSpPr/>
          <p:nvPr/>
        </p:nvSpPr>
        <p:spPr>
          <a:xfrm>
            <a:off x="1412776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矩形 51"/>
          <p:cNvSpPr/>
          <p:nvPr/>
        </p:nvSpPr>
        <p:spPr>
          <a:xfrm>
            <a:off x="6381328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3" name="直接箭头连接符 52"/>
          <p:cNvCxnSpPr/>
          <p:nvPr/>
        </p:nvCxnSpPr>
        <p:spPr>
          <a:xfrm>
            <a:off x="620688" y="8687489"/>
            <a:ext cx="5760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/>
          <p:cNvCxnSpPr/>
          <p:nvPr/>
        </p:nvCxnSpPr>
        <p:spPr>
          <a:xfrm flipH="1" flipV="1">
            <a:off x="620688" y="7895401"/>
            <a:ext cx="0" cy="800472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548680" y="861548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CD8</a:t>
            </a:r>
            <a:endParaRPr lang="zh-CN" altLang="en-US" sz="1200" b="1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151312" y="8220761"/>
            <a:ext cx="78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Tetramer</a:t>
            </a:r>
            <a:endParaRPr lang="zh-CN" altLang="en-US" sz="12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116632" y="8769950"/>
            <a:ext cx="6336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3. MGP-65 specific T cell generation using ETC workflow</a:t>
            </a:r>
            <a:endParaRPr lang="zh-CN" altLang="en-US" sz="16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50533" y="223787"/>
            <a:ext cx="714171" cy="20774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sz="900" b="1" dirty="0"/>
              <a:t>MGP-65 CTL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0688" y="35976"/>
            <a:ext cx="6128767" cy="4320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340768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3356992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/>
        </p:nvSpPr>
        <p:spPr>
          <a:xfrm>
            <a:off x="2348880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4365104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6"/>
          <p:cNvSpPr txBox="1"/>
          <p:nvPr/>
        </p:nvSpPr>
        <p:spPr>
          <a:xfrm>
            <a:off x="-27384" y="259795"/>
            <a:ext cx="858187" cy="20774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sz="900" b="1" dirty="0" smtClean="0"/>
              <a:t>NSP13-242 </a:t>
            </a:r>
            <a:r>
              <a:rPr lang="en-US" sz="900" b="1" dirty="0"/>
              <a:t>CTL</a:t>
            </a:r>
          </a:p>
        </p:txBody>
      </p:sp>
      <p:sp>
        <p:nvSpPr>
          <p:cNvPr id="8" name="矩形 7"/>
          <p:cNvSpPr/>
          <p:nvPr/>
        </p:nvSpPr>
        <p:spPr>
          <a:xfrm>
            <a:off x="5373216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6381328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1340768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3356992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2348880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4365104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5373216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6381328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1340768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3356992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2348880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4365104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5373216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6381328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1340768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3356992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2348880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4365104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5373216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6381328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8" name="Picture 1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0688" y="4355976"/>
            <a:ext cx="6128767" cy="4320000"/>
          </a:xfrm>
          <a:prstGeom prst="rect">
            <a:avLst/>
          </a:prstGeom>
        </p:spPr>
      </p:pic>
      <p:sp>
        <p:nvSpPr>
          <p:cNvPr id="29" name="矩形 28"/>
          <p:cNvSpPr/>
          <p:nvPr/>
        </p:nvSpPr>
        <p:spPr>
          <a:xfrm>
            <a:off x="1340768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3356992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2348880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/>
          <p:cNvSpPr/>
          <p:nvPr/>
        </p:nvSpPr>
        <p:spPr>
          <a:xfrm>
            <a:off x="4365104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5373216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/>
          <p:cNvSpPr/>
          <p:nvPr/>
        </p:nvSpPr>
        <p:spPr>
          <a:xfrm>
            <a:off x="6381328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矩形 34"/>
          <p:cNvSpPr/>
          <p:nvPr/>
        </p:nvSpPr>
        <p:spPr>
          <a:xfrm>
            <a:off x="1340768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/>
          <p:cNvSpPr/>
          <p:nvPr/>
        </p:nvSpPr>
        <p:spPr>
          <a:xfrm>
            <a:off x="3356992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2348880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/>
          <p:cNvSpPr/>
          <p:nvPr/>
        </p:nvSpPr>
        <p:spPr>
          <a:xfrm>
            <a:off x="4365104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5373216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/>
          <p:cNvSpPr/>
          <p:nvPr/>
        </p:nvSpPr>
        <p:spPr>
          <a:xfrm>
            <a:off x="6381328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/>
          <p:cNvSpPr/>
          <p:nvPr/>
        </p:nvSpPr>
        <p:spPr>
          <a:xfrm>
            <a:off x="1340768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/>
          <p:cNvSpPr/>
          <p:nvPr/>
        </p:nvSpPr>
        <p:spPr>
          <a:xfrm>
            <a:off x="3356992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/>
          <p:cNvSpPr/>
          <p:nvPr/>
        </p:nvSpPr>
        <p:spPr>
          <a:xfrm>
            <a:off x="2348880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/>
          <p:cNvSpPr/>
          <p:nvPr/>
        </p:nvSpPr>
        <p:spPr>
          <a:xfrm>
            <a:off x="4365104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/>
          <p:cNvSpPr/>
          <p:nvPr/>
        </p:nvSpPr>
        <p:spPr>
          <a:xfrm>
            <a:off x="5373216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矩形 45"/>
          <p:cNvSpPr/>
          <p:nvPr/>
        </p:nvSpPr>
        <p:spPr>
          <a:xfrm>
            <a:off x="6381328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1340768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3356992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矩形 48"/>
          <p:cNvSpPr/>
          <p:nvPr/>
        </p:nvSpPr>
        <p:spPr>
          <a:xfrm>
            <a:off x="2348880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/>
          <p:cNvSpPr/>
          <p:nvPr/>
        </p:nvSpPr>
        <p:spPr>
          <a:xfrm>
            <a:off x="4365104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矩形 50"/>
          <p:cNvSpPr/>
          <p:nvPr/>
        </p:nvSpPr>
        <p:spPr>
          <a:xfrm>
            <a:off x="5373216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矩形 51"/>
          <p:cNvSpPr/>
          <p:nvPr/>
        </p:nvSpPr>
        <p:spPr>
          <a:xfrm>
            <a:off x="6381328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3" name="直接箭头连接符 52"/>
          <p:cNvCxnSpPr/>
          <p:nvPr/>
        </p:nvCxnSpPr>
        <p:spPr>
          <a:xfrm>
            <a:off x="620688" y="8687489"/>
            <a:ext cx="5760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/>
          <p:cNvCxnSpPr/>
          <p:nvPr/>
        </p:nvCxnSpPr>
        <p:spPr>
          <a:xfrm flipH="1" flipV="1">
            <a:off x="620688" y="7895401"/>
            <a:ext cx="0" cy="800472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548680" y="861548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CD8</a:t>
            </a:r>
            <a:endParaRPr lang="zh-CN" altLang="en-US" sz="1200" b="1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151312" y="8220761"/>
            <a:ext cx="78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Tetramer</a:t>
            </a:r>
            <a:endParaRPr lang="zh-CN" altLang="en-US" sz="12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116632" y="8769950"/>
            <a:ext cx="6336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4. NSP13-242 specific T cell generation using ETC workflow</a:t>
            </a:r>
            <a:endParaRPr lang="zh-CN" altLang="en-US" sz="1600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274728A6-338A-AE41-942B-AE2087F1D18E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0688" y="35976"/>
            <a:ext cx="6128767" cy="432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27384" y="223787"/>
            <a:ext cx="858187" cy="20774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sz="900" b="1" dirty="0" smtClean="0"/>
              <a:t>NSP13-448 </a:t>
            </a:r>
            <a:r>
              <a:rPr lang="en-US" sz="900" b="1" dirty="0"/>
              <a:t>CTL</a:t>
            </a:r>
          </a:p>
        </p:txBody>
      </p:sp>
      <p:pic>
        <p:nvPicPr>
          <p:cNvPr id="4" name="Picture 1">
            <a:extLst>
              <a:ext uri="{FF2B5EF4-FFF2-40B4-BE49-F238E27FC236}">
                <a16:creationId xmlns="" xmlns:a16="http://schemas.microsoft.com/office/drawing/2014/main" id="{ECE8563A-D12A-C34A-9FDC-F7F7918309FA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0688" y="4355976"/>
            <a:ext cx="6128767" cy="43200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2348880" y="6732240"/>
            <a:ext cx="216024" cy="2880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" name="直接箭头连接符 5"/>
          <p:cNvCxnSpPr/>
          <p:nvPr/>
        </p:nvCxnSpPr>
        <p:spPr>
          <a:xfrm>
            <a:off x="620688" y="8687489"/>
            <a:ext cx="5760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/>
          <p:cNvCxnSpPr/>
          <p:nvPr/>
        </p:nvCxnSpPr>
        <p:spPr>
          <a:xfrm flipH="1" flipV="1">
            <a:off x="620688" y="7895401"/>
            <a:ext cx="0" cy="800472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48680" y="861548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CD8</a:t>
            </a:r>
            <a:endParaRPr lang="zh-CN" altLang="en-US" sz="1200" b="1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151312" y="8220761"/>
            <a:ext cx="78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Tetramer</a:t>
            </a:r>
            <a:endParaRPr lang="zh-CN" altLang="en-US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16632" y="8769950"/>
            <a:ext cx="6336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5. NSP13-448 specific T cell generation using ETC workflow</a:t>
            </a:r>
            <a:endParaRPr lang="zh-CN" altLang="en-US" sz="1600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>
            <a:extLst>
              <a:ext uri="{FF2B5EF4-FFF2-40B4-BE49-F238E27FC236}">
                <a16:creationId xmlns="" xmlns:a16="http://schemas.microsoft.com/office/drawing/2014/main" id="{18BAB519-8CCE-1F4B-933B-66A4EDEF3ED1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0688" y="35976"/>
            <a:ext cx="6116904" cy="432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27384" y="223787"/>
            <a:ext cx="858187" cy="20774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sz="900" b="1" dirty="0" smtClean="0"/>
              <a:t>NSP13-134 </a:t>
            </a:r>
            <a:r>
              <a:rPr lang="en-US" sz="900" b="1" dirty="0"/>
              <a:t>CTL</a:t>
            </a:r>
          </a:p>
        </p:txBody>
      </p:sp>
      <p:pic>
        <p:nvPicPr>
          <p:cNvPr id="4" name="Picture 1">
            <a:extLst>
              <a:ext uri="{FF2B5EF4-FFF2-40B4-BE49-F238E27FC236}">
                <a16:creationId xmlns="" xmlns:a16="http://schemas.microsoft.com/office/drawing/2014/main" id="{A830C671-A17C-9E4E-B78F-1ED75893F5CC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0688" y="4355976"/>
            <a:ext cx="6116904" cy="43200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340768" y="13316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1340768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1340768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2348880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6381328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2348880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3356992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5373216" y="4644008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6309320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2348880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4365104" y="78123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620688" y="8687489"/>
            <a:ext cx="5760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 flipH="1" flipV="1">
            <a:off x="620688" y="7895401"/>
            <a:ext cx="0" cy="800472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548680" y="861548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CD8</a:t>
            </a:r>
            <a:endParaRPr lang="zh-CN" altLang="en-US" sz="120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151312" y="8220761"/>
            <a:ext cx="78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Tetramer</a:t>
            </a:r>
            <a:endParaRPr lang="zh-CN" altLang="en-US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16632" y="8769950"/>
            <a:ext cx="6336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6. NSP13-134 specific T cell generation using ETC workflow</a:t>
            </a:r>
            <a:endParaRPr lang="zh-CN" altLang="en-US" sz="1600" b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20688" y="35976"/>
            <a:ext cx="6143244" cy="432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27384" y="223787"/>
            <a:ext cx="858187" cy="207749"/>
          </a:xfrm>
          <a:prstGeom prst="rect">
            <a:avLst/>
          </a:prstGeom>
          <a:noFill/>
        </p:spPr>
        <p:txBody>
          <a:bodyPr wrap="square" lIns="68580" tIns="34290" rIns="68580" bIns="34290" rtlCol="0">
            <a:spAutoFit/>
          </a:bodyPr>
          <a:lstStyle/>
          <a:p>
            <a:r>
              <a:rPr lang="en-US" sz="900" b="1" dirty="0" smtClean="0"/>
              <a:t>NSP13-400 </a:t>
            </a:r>
            <a:r>
              <a:rPr lang="en-US" sz="900" b="1" dirty="0"/>
              <a:t>CTL</a:t>
            </a:r>
          </a:p>
        </p:txBody>
      </p:sp>
      <p:pic>
        <p:nvPicPr>
          <p:cNvPr id="4" name="Picture 1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20688" y="4355976"/>
            <a:ext cx="6143244" cy="43200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268760" y="241176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1268760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5301208" y="2515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1268760" y="349188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1268760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5301208" y="457200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6309320" y="565212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6309320" y="673224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" name="直接箭头连接符 12"/>
          <p:cNvCxnSpPr/>
          <p:nvPr/>
        </p:nvCxnSpPr>
        <p:spPr>
          <a:xfrm>
            <a:off x="620688" y="8687489"/>
            <a:ext cx="5760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 flipH="1" flipV="1">
            <a:off x="620688" y="7895401"/>
            <a:ext cx="0" cy="800472"/>
          </a:xfrm>
          <a:prstGeom prst="straightConnector1">
            <a:avLst/>
          </a:prstGeom>
          <a:ln w="19050">
            <a:solidFill>
              <a:schemeClr val="tx1"/>
            </a:solidFill>
            <a:tailEnd type="triangle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48680" y="861548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CD8</a:t>
            </a:r>
            <a:endParaRPr lang="zh-CN" altLang="en-US" sz="1200" b="1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151312" y="8220761"/>
            <a:ext cx="78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Tetramer</a:t>
            </a:r>
            <a:endParaRPr lang="zh-CN" alt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16632" y="8769950"/>
            <a:ext cx="63367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Fig. S7. NSP13-400 specific T cell generation using ETC workflow</a:t>
            </a:r>
            <a:endParaRPr lang="zh-CN" altLang="en-US" sz="16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113</Words>
  <Application>Microsoft Office PowerPoint</Application>
  <PresentationFormat>信纸(8.5x11 英寸)</PresentationFormat>
  <Paragraphs>22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潘科</dc:creator>
  <cp:lastModifiedBy>潘科</cp:lastModifiedBy>
  <cp:revision>91</cp:revision>
  <dcterms:created xsi:type="dcterms:W3CDTF">2021-04-10T22:29:45Z</dcterms:created>
  <dcterms:modified xsi:type="dcterms:W3CDTF">2021-07-08T02:26:23Z</dcterms:modified>
</cp:coreProperties>
</file>